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797675" cy="992822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dy&amp;Fede" initials="A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C000"/>
    <a:srgbClr val="BC3C29"/>
    <a:srgbClr val="4472C4"/>
    <a:srgbClr val="D78B7F"/>
    <a:srgbClr val="0070C1"/>
    <a:srgbClr val="909090"/>
    <a:srgbClr val="EEBB00"/>
    <a:srgbClr val="FF8000"/>
    <a:srgbClr val="0000FF"/>
    <a:srgbClr val="09996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–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786" autoAdjust="0"/>
    <p:restoredTop sz="94626"/>
  </p:normalViewPr>
  <p:slideViewPr>
    <p:cSldViewPr snapToGrid="0">
      <p:cViewPr varScale="1">
        <p:scale>
          <a:sx n="90" d="100"/>
          <a:sy n="90" d="100"/>
        </p:scale>
        <p:origin x="46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FFB83E-C48E-447E-9B3B-133D6A49D7EE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F49B13-6FF4-4488-95DA-3919E18726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5995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Inserire VAF TP53 ut?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F49B13-6FF4-4488-95DA-3919E187264A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63322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A63C0C-5577-4C4F-61B3-CAFB123513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A603D7D-CEDD-0E8C-733F-1419457099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35D4-5E28-43CC-4258-10D5F57B8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88FB44-08E5-DC01-F286-00A4B70CA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9D877C2-5464-507D-9398-03A3954C4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6497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55BF24-0E63-E15D-0FB7-6DED958D6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6F4C177-79C7-F108-008D-55C2DB7060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34BE381-0992-F1D1-47A1-D82412118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9067EC9-B9E8-9182-06AE-3D28BFF98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6D62368-E692-E3D8-85A8-A9760E775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667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B6A7F61-ACE5-5156-1B30-49C52B4F7D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0801A64-95FE-B96E-B84E-D892265FE7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693709-87BF-F58D-A0C8-091B34C12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0CD796-6F33-DF2E-3351-C9A261969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CB49C7-3337-9EE1-CC4B-A57EE1D14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5806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34808E-2EBC-C139-9D9D-4BD441DA0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B8B1B5-AF78-546E-1B4F-3B72E71BC5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A1BC50-4AFE-3E13-8410-C351AA72B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E9C010-CE3B-EEDC-B29C-F358AAD89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00AB1A3-863D-D8AE-A5C2-4506665F7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770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ECB986-6728-CA75-D17B-453452C00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504A5FD-A86A-D366-A583-981DE08834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AB1E49-EAB1-E1AB-FA38-F86BAFE38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B0A145-6BA2-FFE0-05CC-06367F3F4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B737D9-BE9B-7F61-C270-66ADD4B6E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596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1DA176-9AEF-86A0-F853-93C569731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7EC949C-DECD-3F5C-9081-E837876ED4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1ADA58F-20A5-8915-5085-F6E80775AC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8725F3F-94E5-3B09-4810-6F8AB0076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850594C-1CE5-043C-1F64-D8D77BF75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96FF6CC-5708-74BF-ED94-E3E857F3E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8148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792884-E46C-7B85-42C6-0100C1ABF0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BD0A09C-C24B-1866-FC96-B9F4C7E95A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F1F5CB0-6543-A984-7EF7-7815646F1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46EB3B6-1505-4468-6143-C658F31EBF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4C82EC3-B6CF-B4F8-A541-245CBF0EBA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5D12E8C-B186-5A7E-BDB9-6EDEAE98E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EB10F3A-2B17-3E0C-5B31-371A9444A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29D86D7-A67F-BC78-13A0-B8225D41D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9179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862856-CEAD-F763-03ED-ADAFCB54A9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B020A37-17B0-BDCD-E5E9-EED476A7D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108FC7F-14D6-FBEC-16B3-392247F5A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60DF6CA-D338-828B-87C9-16AE0A244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0379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A4D705D-6731-3F07-784A-21C538175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B681606-DC1A-7757-FB04-1591E3AC4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6483D9F-9708-6D4A-35CA-7F78CBC4C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250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FB8B3C-31B6-5DA6-3C01-C47FF05C7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F3FECB9-35C2-12D2-C0CD-1E2FEDB41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BD989E8-83D8-8F0F-A3BF-2BEC740C55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A96B903-B458-252B-17FA-3B4F6A23C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0EDD6C9-0DE3-A03D-4B8D-AC2A274040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B092D31-AA36-9F61-447A-01421E7B1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1690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3A27E8-DF0C-AC6A-5538-C06A86CD3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EAAA7EB-851F-32CC-D3EB-8C30D2AA72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FEA5DBA-8946-549E-49FF-A963F8924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CD64142-E4FE-4056-6459-99012726D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D0E2D54-7485-9ED6-5B32-EDC22F6FC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A6305A-BC26-554B-6728-9DFD3DE39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823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E6D9B43-DA48-B1BD-F6A8-DEF111A76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D41DCF3-5DF7-90C3-3022-EE4630C32C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337486-CF24-BF87-82A2-D50C982582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E592BA-4B9A-BC56-5D65-520F78FDF8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412DB8-AEFC-A7A2-C09A-EE8DD88FBF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8314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9902DCA8-B1EE-4CED-A5A7-636AEFDB9F31}"/>
              </a:ext>
            </a:extLst>
          </p:cNvPr>
          <p:cNvSpPr txBox="1"/>
          <p:nvPr/>
        </p:nvSpPr>
        <p:spPr>
          <a:xfrm>
            <a:off x="264616" y="212330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a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7E24565B-F3EB-7D64-AB92-A0ABA20C7726}"/>
              </a:ext>
            </a:extLst>
          </p:cNvPr>
          <p:cNvSpPr txBox="1"/>
          <p:nvPr/>
        </p:nvSpPr>
        <p:spPr>
          <a:xfrm>
            <a:off x="4181255" y="212329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b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109458F0-A1D9-3511-3F28-101D5FD01B73}"/>
              </a:ext>
            </a:extLst>
          </p:cNvPr>
          <p:cNvSpPr txBox="1"/>
          <p:nvPr/>
        </p:nvSpPr>
        <p:spPr>
          <a:xfrm>
            <a:off x="905025" y="516865"/>
            <a:ext cx="14132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i="1" dirty="0" err="1"/>
              <a:t>assay</a:t>
            </a:r>
            <a:r>
              <a:rPr lang="it-IT" sz="900" i="1" dirty="0"/>
              <a:t>: TP53 p.R282W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C7E4965D-C4E6-7B0D-CA33-F5160ECA0953}"/>
              </a:ext>
            </a:extLst>
          </p:cNvPr>
          <p:cNvSpPr txBox="1"/>
          <p:nvPr/>
        </p:nvSpPr>
        <p:spPr>
          <a:xfrm>
            <a:off x="905025" y="1503871"/>
            <a:ext cx="1380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i="1" dirty="0" err="1"/>
              <a:t>assay</a:t>
            </a:r>
            <a:r>
              <a:rPr lang="it-IT" sz="900" i="1" dirty="0"/>
              <a:t>: TP53 p.R175H</a:t>
            </a: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6099828A-641C-501F-10C5-C13B54748938}"/>
              </a:ext>
            </a:extLst>
          </p:cNvPr>
          <p:cNvSpPr txBox="1"/>
          <p:nvPr/>
        </p:nvSpPr>
        <p:spPr>
          <a:xfrm rot="16200000">
            <a:off x="3938255" y="1091002"/>
            <a:ext cx="13322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/>
              <a:t>Relative </a:t>
            </a:r>
            <a:r>
              <a:rPr lang="it-IT" sz="1000" dirty="0" err="1"/>
              <a:t>expression</a:t>
            </a:r>
            <a:r>
              <a:rPr lang="it-IT" sz="1000" dirty="0"/>
              <a:t> of </a:t>
            </a:r>
          </a:p>
          <a:p>
            <a:pPr algn="ctr"/>
            <a:r>
              <a:rPr lang="it-IT" sz="1000" dirty="0" err="1"/>
              <a:t>miRNA</a:t>
            </a:r>
            <a:r>
              <a:rPr lang="it-IT" sz="1000" dirty="0"/>
              <a:t> signature</a:t>
            </a:r>
          </a:p>
        </p:txBody>
      </p:sp>
      <p:graphicFrame>
        <p:nvGraphicFramePr>
          <p:cNvPr id="13" name="Oggetto 12">
            <a:extLst>
              <a:ext uri="{FF2B5EF4-FFF2-40B4-BE49-F238E27FC236}">
                <a16:creationId xmlns:a16="http://schemas.microsoft.com/office/drawing/2014/main" id="{53D1A080-B488-84A2-DA1D-888502CE78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0551744"/>
              </p:ext>
            </p:extLst>
          </p:nvPr>
        </p:nvGraphicFramePr>
        <p:xfrm>
          <a:off x="4743109" y="520106"/>
          <a:ext cx="2598738" cy="1633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129939" imgH="2166687" progId="Prism9.Document">
                  <p:embed/>
                </p:oleObj>
              </mc:Choice>
              <mc:Fallback>
                <p:oleObj name="Prism 9" r:id="rId3" imgW="3129939" imgH="2166687" progId="Prism9.Document">
                  <p:embed/>
                  <p:pic>
                    <p:nvPicPr>
                      <p:cNvPr id="13" name="Oggetto 12">
                        <a:extLst>
                          <a:ext uri="{FF2B5EF4-FFF2-40B4-BE49-F238E27FC236}">
                            <a16:creationId xmlns:a16="http://schemas.microsoft.com/office/drawing/2014/main" id="{53D1A080-B488-84A2-DA1D-888502CE78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43109" y="520106"/>
                        <a:ext cx="2598738" cy="1633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204D3C39-0FA8-08B1-ED1E-78E60D565A9D}"/>
              </a:ext>
            </a:extLst>
          </p:cNvPr>
          <p:cNvSpPr txBox="1"/>
          <p:nvPr/>
        </p:nvSpPr>
        <p:spPr>
          <a:xfrm>
            <a:off x="5131342" y="521833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#1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049F979D-EA2A-1490-8D87-1DE1D8C5F4CA}"/>
              </a:ext>
            </a:extLst>
          </p:cNvPr>
          <p:cNvSpPr txBox="1"/>
          <p:nvPr/>
        </p:nvSpPr>
        <p:spPr>
          <a:xfrm>
            <a:off x="5550747" y="521833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#2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4049EC52-2563-DE88-18F4-0562A17C6F87}"/>
              </a:ext>
            </a:extLst>
          </p:cNvPr>
          <p:cNvSpPr txBox="1"/>
          <p:nvPr/>
        </p:nvSpPr>
        <p:spPr>
          <a:xfrm>
            <a:off x="5970152" y="521833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#3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4AD380F9-A892-3655-A86B-12CCB9419D68}"/>
              </a:ext>
            </a:extLst>
          </p:cNvPr>
          <p:cNvSpPr txBox="1"/>
          <p:nvPr/>
        </p:nvSpPr>
        <p:spPr>
          <a:xfrm>
            <a:off x="6389557" y="521833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#4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3582DE6C-74CD-F3DB-A620-B1C6FF5FAC08}"/>
              </a:ext>
            </a:extLst>
          </p:cNvPr>
          <p:cNvSpPr txBox="1"/>
          <p:nvPr/>
        </p:nvSpPr>
        <p:spPr>
          <a:xfrm>
            <a:off x="5059165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A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1A20994F-4D6F-F765-9BB9-2B5633660058}"/>
              </a:ext>
            </a:extLst>
          </p:cNvPr>
          <p:cNvSpPr txBox="1"/>
          <p:nvPr/>
        </p:nvSpPr>
        <p:spPr>
          <a:xfrm>
            <a:off x="5266316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C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432E2F29-840B-E5B8-189A-9C8D660ED261}"/>
              </a:ext>
            </a:extLst>
          </p:cNvPr>
          <p:cNvSpPr txBox="1"/>
          <p:nvPr/>
        </p:nvSpPr>
        <p:spPr>
          <a:xfrm>
            <a:off x="5473467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A</a:t>
            </a: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CDE8B143-FCBF-8950-8C7F-89EE158FA3D6}"/>
              </a:ext>
            </a:extLst>
          </p:cNvPr>
          <p:cNvSpPr txBox="1"/>
          <p:nvPr/>
        </p:nvSpPr>
        <p:spPr>
          <a:xfrm>
            <a:off x="5680618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C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DA980927-A92A-4026-4659-79DF87EE125B}"/>
              </a:ext>
            </a:extLst>
          </p:cNvPr>
          <p:cNvSpPr txBox="1"/>
          <p:nvPr/>
        </p:nvSpPr>
        <p:spPr>
          <a:xfrm>
            <a:off x="5887769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A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675FC174-EF09-9F16-EFE8-EBC67671285F}"/>
              </a:ext>
            </a:extLst>
          </p:cNvPr>
          <p:cNvSpPr txBox="1"/>
          <p:nvPr/>
        </p:nvSpPr>
        <p:spPr>
          <a:xfrm>
            <a:off x="6094920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C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629141C4-DB78-81D9-9391-4648093090BC}"/>
              </a:ext>
            </a:extLst>
          </p:cNvPr>
          <p:cNvSpPr txBox="1"/>
          <p:nvPr/>
        </p:nvSpPr>
        <p:spPr>
          <a:xfrm>
            <a:off x="6302071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A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0C657949-252C-984B-0EBF-AA3CA8E9D328}"/>
              </a:ext>
            </a:extLst>
          </p:cNvPr>
          <p:cNvSpPr txBox="1"/>
          <p:nvPr/>
        </p:nvSpPr>
        <p:spPr>
          <a:xfrm>
            <a:off x="6509222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B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FDBC3F29-B672-FBDE-E698-C14074F6F28D}"/>
              </a:ext>
            </a:extLst>
          </p:cNvPr>
          <p:cNvSpPr txBox="1"/>
          <p:nvPr/>
        </p:nvSpPr>
        <p:spPr>
          <a:xfrm>
            <a:off x="6808962" y="521833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#5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0A2CD3F1-CE88-7F70-F229-DED087215796}"/>
              </a:ext>
            </a:extLst>
          </p:cNvPr>
          <p:cNvSpPr txBox="1"/>
          <p:nvPr/>
        </p:nvSpPr>
        <p:spPr>
          <a:xfrm>
            <a:off x="6716373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A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835F972C-0523-57FD-4A68-5F2E1CBF3330}"/>
              </a:ext>
            </a:extLst>
          </p:cNvPr>
          <p:cNvSpPr txBox="1"/>
          <p:nvPr/>
        </p:nvSpPr>
        <p:spPr>
          <a:xfrm>
            <a:off x="6923528" y="20675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C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8C6E3024-7D75-6BA0-32F1-CBB14AACB1A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05616" y="754696"/>
            <a:ext cx="1499131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281259B8-642B-B9A8-7B04-FE5D34E02B6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65065" y="754696"/>
            <a:ext cx="1477358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FECCC58A-73B3-0D18-D52B-950064F1B98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65065" y="1739804"/>
            <a:ext cx="1477358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A9A0AD51-2C66-DBDB-2560-94F78C17802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16502" y="1739804"/>
            <a:ext cx="1477358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0ED45B23-0A09-1E79-23E2-F66565B6CA94}"/>
              </a:ext>
            </a:extLst>
          </p:cNvPr>
          <p:cNvSpPr txBox="1"/>
          <p:nvPr/>
        </p:nvSpPr>
        <p:spPr>
          <a:xfrm>
            <a:off x="3303744" y="752558"/>
            <a:ext cx="7344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b="1" dirty="0"/>
              <a:t>ctDNA pt#2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FB41B3A6-190A-E50B-B5B5-6687C153690D}"/>
              </a:ext>
            </a:extLst>
          </p:cNvPr>
          <p:cNvSpPr txBox="1"/>
          <p:nvPr/>
        </p:nvSpPr>
        <p:spPr>
          <a:xfrm>
            <a:off x="2132997" y="757223"/>
            <a:ext cx="3754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b="1" dirty="0"/>
              <a:t>NTC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38F9B572-A7E6-AD12-6ED7-B9F47DAAAC00}"/>
              </a:ext>
            </a:extLst>
          </p:cNvPr>
          <p:cNvSpPr txBox="1"/>
          <p:nvPr/>
        </p:nvSpPr>
        <p:spPr>
          <a:xfrm>
            <a:off x="3314362" y="1737722"/>
            <a:ext cx="7344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b="1" dirty="0"/>
              <a:t>ctDNA pt#3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A02E6547-12CA-21EF-D233-508E4765A15B}"/>
              </a:ext>
            </a:extLst>
          </p:cNvPr>
          <p:cNvSpPr txBox="1"/>
          <p:nvPr/>
        </p:nvSpPr>
        <p:spPr>
          <a:xfrm>
            <a:off x="2143615" y="1742387"/>
            <a:ext cx="3754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b="1" dirty="0"/>
              <a:t>NTC</a:t>
            </a:r>
          </a:p>
        </p:txBody>
      </p:sp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D4DB082D-2F90-E3C7-67AF-94D13430B5EC}"/>
              </a:ext>
            </a:extLst>
          </p:cNvPr>
          <p:cNvCxnSpPr>
            <a:cxnSpLocks/>
          </p:cNvCxnSpPr>
          <p:nvPr/>
        </p:nvCxnSpPr>
        <p:spPr>
          <a:xfrm flipV="1">
            <a:off x="905025" y="754696"/>
            <a:ext cx="0" cy="1705108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B4630C9-5E57-E1B2-336A-DB0B48AC1CBC}"/>
              </a:ext>
            </a:extLst>
          </p:cNvPr>
          <p:cNvSpPr txBox="1"/>
          <p:nvPr/>
        </p:nvSpPr>
        <p:spPr>
          <a:xfrm rot="16200000">
            <a:off x="-111783" y="1398398"/>
            <a:ext cx="16364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/>
              <a:t>FAM </a:t>
            </a:r>
            <a:r>
              <a:rPr lang="it-IT" sz="1000" dirty="0" err="1"/>
              <a:t>fluorescence</a:t>
            </a:r>
            <a:endParaRPr lang="it-IT" sz="1000" dirty="0"/>
          </a:p>
          <a:p>
            <a:pPr algn="ctr"/>
            <a:r>
              <a:rPr lang="it-IT" sz="1000" dirty="0"/>
              <a:t>(</a:t>
            </a:r>
            <a:r>
              <a:rPr lang="it-IT" sz="1000" dirty="0" err="1"/>
              <a:t>mutant</a:t>
            </a:r>
            <a:r>
              <a:rPr lang="it-IT" sz="1000" dirty="0"/>
              <a:t> allele)</a:t>
            </a:r>
          </a:p>
        </p:txBody>
      </p:sp>
      <p:cxnSp>
        <p:nvCxnSpPr>
          <p:cNvPr id="14" name="Connettore 2 13">
            <a:extLst>
              <a:ext uri="{FF2B5EF4-FFF2-40B4-BE49-F238E27FC236}">
                <a16:creationId xmlns:a16="http://schemas.microsoft.com/office/drawing/2014/main" id="{7F111DFA-A0FC-5B8C-592A-D43AD3EDFE3C}"/>
              </a:ext>
            </a:extLst>
          </p:cNvPr>
          <p:cNvCxnSpPr>
            <a:cxnSpLocks/>
          </p:cNvCxnSpPr>
          <p:nvPr/>
        </p:nvCxnSpPr>
        <p:spPr>
          <a:xfrm>
            <a:off x="1016502" y="2543316"/>
            <a:ext cx="3021738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470C185-595D-5CCB-DA7B-0F77C3752F5A}"/>
              </a:ext>
            </a:extLst>
          </p:cNvPr>
          <p:cNvSpPr txBox="1"/>
          <p:nvPr/>
        </p:nvSpPr>
        <p:spPr>
          <a:xfrm>
            <a:off x="1016502" y="2547990"/>
            <a:ext cx="30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/>
              <a:t>VIC </a:t>
            </a:r>
            <a:r>
              <a:rPr lang="it-IT" sz="1000" dirty="0" err="1"/>
              <a:t>fluorescence</a:t>
            </a:r>
            <a:endParaRPr lang="it-IT" sz="1000" dirty="0"/>
          </a:p>
          <a:p>
            <a:pPr algn="ctr"/>
            <a:r>
              <a:rPr lang="it-IT" sz="1000" dirty="0"/>
              <a:t>(wild </a:t>
            </a:r>
            <a:r>
              <a:rPr lang="it-IT" sz="1000" dirty="0" err="1"/>
              <a:t>type</a:t>
            </a:r>
            <a:r>
              <a:rPr lang="it-IT" sz="1000" dirty="0"/>
              <a:t> allele)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91EB6D3C-053B-523C-124C-BC92E84C2E3C}"/>
              </a:ext>
            </a:extLst>
          </p:cNvPr>
          <p:cNvSpPr txBox="1"/>
          <p:nvPr/>
        </p:nvSpPr>
        <p:spPr>
          <a:xfrm>
            <a:off x="3373475" y="895550"/>
            <a:ext cx="5950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700" dirty="0"/>
              <a:t>VAF: 0.37%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B2CE9B6D-5CFA-772B-EC4B-6434768EBE5F}"/>
              </a:ext>
            </a:extLst>
          </p:cNvPr>
          <p:cNvSpPr txBox="1"/>
          <p:nvPr/>
        </p:nvSpPr>
        <p:spPr>
          <a:xfrm>
            <a:off x="3384093" y="1907354"/>
            <a:ext cx="5950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700" dirty="0"/>
              <a:t>VAF: 0.32%</a:t>
            </a:r>
          </a:p>
        </p:txBody>
      </p:sp>
    </p:spTree>
    <p:extLst>
      <p:ext uri="{BB962C8B-B14F-4D97-AF65-F5344CB8AC3E}">
        <p14:creationId xmlns:p14="http://schemas.microsoft.com/office/powerpoint/2010/main" val="26053968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Office PowerPoint</Application>
  <PresentationFormat>Widescreen</PresentationFormat>
  <Paragraphs>33</Paragraphs>
  <Slides>1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9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416</cp:revision>
  <cp:lastPrinted>2023-10-12T13:56:18Z</cp:lastPrinted>
  <dcterms:created xsi:type="dcterms:W3CDTF">2022-08-04T15:26:16Z</dcterms:created>
  <dcterms:modified xsi:type="dcterms:W3CDTF">2024-02-13T16:31:15Z</dcterms:modified>
</cp:coreProperties>
</file>